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56" r:id="rId2"/>
  </p:sldIdLst>
  <p:sldSz cx="20421600" cy="15087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65806" autoAdjust="0"/>
  </p:normalViewPr>
  <p:slideViewPr>
    <p:cSldViewPr snapToGrid="0">
      <p:cViewPr varScale="1">
        <p:scale>
          <a:sx n="49" d="100"/>
          <a:sy n="49" d="100"/>
        </p:scale>
        <p:origin x="15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Research%20Collaborations\writing\working%20file%20for%20figures%20and%20tables\Figure%203C%20data%20List%20of%20differentially%20expresed%20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12093941700547"/>
          <c:y val="8.8112569262175561E-2"/>
          <c:w val="0.81843295269765348"/>
          <c:h val="0.76715173212175991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20</c:f>
              <c:strCache>
                <c:ptCount val="18"/>
                <c:pt idx="0">
                  <c:v>P-S2_vs_P-S1</c:v>
                </c:pt>
                <c:pt idx="1">
                  <c:v>P-S3_vs_P-S2</c:v>
                </c:pt>
                <c:pt idx="2">
                  <c:v>T-S3_vs_T-S2</c:v>
                </c:pt>
                <c:pt idx="3">
                  <c:v>T-S2_vs_T-S1</c:v>
                </c:pt>
                <c:pt idx="4">
                  <c:v>S-S3_vs_S-S2</c:v>
                </c:pt>
                <c:pt idx="5">
                  <c:v>P-S3_vs_P-S1</c:v>
                </c:pt>
                <c:pt idx="6">
                  <c:v>S-S2_vs_S-S1</c:v>
                </c:pt>
                <c:pt idx="7">
                  <c:v>T-S3_vs_T-S1</c:v>
                </c:pt>
                <c:pt idx="8">
                  <c:v>S-S3_vs_S-S1</c:v>
                </c:pt>
                <c:pt idx="9">
                  <c:v>S-S1_vs_T-S1</c:v>
                </c:pt>
                <c:pt idx="10">
                  <c:v>S-S2_vs_T-S2</c:v>
                </c:pt>
                <c:pt idx="11">
                  <c:v>S-S3_vs_T-S3</c:v>
                </c:pt>
                <c:pt idx="12">
                  <c:v>P-S2_vs_T-S2</c:v>
                </c:pt>
                <c:pt idx="13">
                  <c:v>P-S3_vs_T-S3</c:v>
                </c:pt>
                <c:pt idx="14">
                  <c:v>P-S1_vs_T-S1</c:v>
                </c:pt>
                <c:pt idx="15">
                  <c:v>S-S1_vs_P-S1</c:v>
                </c:pt>
                <c:pt idx="16">
                  <c:v>S-S3_vs_P-S3</c:v>
                </c:pt>
                <c:pt idx="17">
                  <c:v>S-S2_vs_P-S2</c:v>
                </c:pt>
              </c:strCache>
            </c:strRef>
          </c:cat>
          <c:val>
            <c:numRef>
              <c:f>Sheet1!$B$3:$B$20</c:f>
              <c:numCache>
                <c:formatCode>General</c:formatCode>
                <c:ptCount val="18"/>
                <c:pt idx="0">
                  <c:v>1711</c:v>
                </c:pt>
                <c:pt idx="1">
                  <c:v>2169</c:v>
                </c:pt>
                <c:pt idx="2">
                  <c:v>2297</c:v>
                </c:pt>
                <c:pt idx="3">
                  <c:v>2648</c:v>
                </c:pt>
                <c:pt idx="4">
                  <c:v>3908</c:v>
                </c:pt>
                <c:pt idx="5">
                  <c:v>6049</c:v>
                </c:pt>
                <c:pt idx="6">
                  <c:v>9100</c:v>
                </c:pt>
                <c:pt idx="7">
                  <c:v>7938</c:v>
                </c:pt>
                <c:pt idx="8">
                  <c:v>14929</c:v>
                </c:pt>
                <c:pt idx="9">
                  <c:v>15966</c:v>
                </c:pt>
                <c:pt idx="10">
                  <c:v>18929</c:v>
                </c:pt>
                <c:pt idx="11">
                  <c:v>19495</c:v>
                </c:pt>
                <c:pt idx="12">
                  <c:v>24086</c:v>
                </c:pt>
                <c:pt idx="13">
                  <c:v>25887</c:v>
                </c:pt>
                <c:pt idx="14">
                  <c:v>26953</c:v>
                </c:pt>
                <c:pt idx="15">
                  <c:v>32362</c:v>
                </c:pt>
                <c:pt idx="16">
                  <c:v>33898</c:v>
                </c:pt>
                <c:pt idx="17">
                  <c:v>353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DC-41FB-97A6-E5466C5DE0D0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chemeClr val="accent2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20</c:f>
              <c:strCache>
                <c:ptCount val="18"/>
                <c:pt idx="0">
                  <c:v>P-S2_vs_P-S1</c:v>
                </c:pt>
                <c:pt idx="1">
                  <c:v>P-S3_vs_P-S2</c:v>
                </c:pt>
                <c:pt idx="2">
                  <c:v>T-S3_vs_T-S2</c:v>
                </c:pt>
                <c:pt idx="3">
                  <c:v>T-S2_vs_T-S1</c:v>
                </c:pt>
                <c:pt idx="4">
                  <c:v>S-S3_vs_S-S2</c:v>
                </c:pt>
                <c:pt idx="5">
                  <c:v>P-S3_vs_P-S1</c:v>
                </c:pt>
                <c:pt idx="6">
                  <c:v>S-S2_vs_S-S1</c:v>
                </c:pt>
                <c:pt idx="7">
                  <c:v>T-S3_vs_T-S1</c:v>
                </c:pt>
                <c:pt idx="8">
                  <c:v>S-S3_vs_S-S1</c:v>
                </c:pt>
                <c:pt idx="9">
                  <c:v>S-S1_vs_T-S1</c:v>
                </c:pt>
                <c:pt idx="10">
                  <c:v>S-S2_vs_T-S2</c:v>
                </c:pt>
                <c:pt idx="11">
                  <c:v>S-S3_vs_T-S3</c:v>
                </c:pt>
                <c:pt idx="12">
                  <c:v>P-S2_vs_T-S2</c:v>
                </c:pt>
                <c:pt idx="13">
                  <c:v>P-S3_vs_T-S3</c:v>
                </c:pt>
                <c:pt idx="14">
                  <c:v>P-S1_vs_T-S1</c:v>
                </c:pt>
                <c:pt idx="15">
                  <c:v>S-S1_vs_P-S1</c:v>
                </c:pt>
                <c:pt idx="16">
                  <c:v>S-S3_vs_P-S3</c:v>
                </c:pt>
                <c:pt idx="17">
                  <c:v>S-S2_vs_P-S2</c:v>
                </c:pt>
              </c:strCache>
            </c:strRef>
          </c:cat>
          <c:val>
            <c:numRef>
              <c:f>Sheet1!$C$3:$C$20</c:f>
              <c:numCache>
                <c:formatCode>General</c:formatCode>
                <c:ptCount val="18"/>
                <c:pt idx="0">
                  <c:v>1109</c:v>
                </c:pt>
                <c:pt idx="1">
                  <c:v>1479</c:v>
                </c:pt>
                <c:pt idx="2">
                  <c:v>1200</c:v>
                </c:pt>
                <c:pt idx="3">
                  <c:v>1300</c:v>
                </c:pt>
                <c:pt idx="4">
                  <c:v>1671</c:v>
                </c:pt>
                <c:pt idx="5">
                  <c:v>3757</c:v>
                </c:pt>
                <c:pt idx="6">
                  <c:v>5214</c:v>
                </c:pt>
                <c:pt idx="7">
                  <c:v>3908</c:v>
                </c:pt>
                <c:pt idx="8">
                  <c:v>8336</c:v>
                </c:pt>
                <c:pt idx="9">
                  <c:v>8624</c:v>
                </c:pt>
                <c:pt idx="10">
                  <c:v>10113</c:v>
                </c:pt>
                <c:pt idx="11">
                  <c:v>10572</c:v>
                </c:pt>
                <c:pt idx="12">
                  <c:v>12980</c:v>
                </c:pt>
                <c:pt idx="13">
                  <c:v>14251</c:v>
                </c:pt>
                <c:pt idx="14">
                  <c:v>14677</c:v>
                </c:pt>
                <c:pt idx="15">
                  <c:v>14854</c:v>
                </c:pt>
                <c:pt idx="16">
                  <c:v>15859</c:v>
                </c:pt>
                <c:pt idx="17">
                  <c:v>160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2DC-41FB-97A6-E5466C5DE0D0}"/>
            </c:ext>
          </c:extLst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3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3:$A$20</c:f>
              <c:strCache>
                <c:ptCount val="18"/>
                <c:pt idx="0">
                  <c:v>P-S2_vs_P-S1</c:v>
                </c:pt>
                <c:pt idx="1">
                  <c:v>P-S3_vs_P-S2</c:v>
                </c:pt>
                <c:pt idx="2">
                  <c:v>T-S3_vs_T-S2</c:v>
                </c:pt>
                <c:pt idx="3">
                  <c:v>T-S2_vs_T-S1</c:v>
                </c:pt>
                <c:pt idx="4">
                  <c:v>S-S3_vs_S-S2</c:v>
                </c:pt>
                <c:pt idx="5">
                  <c:v>P-S3_vs_P-S1</c:v>
                </c:pt>
                <c:pt idx="6">
                  <c:v>S-S2_vs_S-S1</c:v>
                </c:pt>
                <c:pt idx="7">
                  <c:v>T-S3_vs_T-S1</c:v>
                </c:pt>
                <c:pt idx="8">
                  <c:v>S-S3_vs_S-S1</c:v>
                </c:pt>
                <c:pt idx="9">
                  <c:v>S-S1_vs_T-S1</c:v>
                </c:pt>
                <c:pt idx="10">
                  <c:v>S-S2_vs_T-S2</c:v>
                </c:pt>
                <c:pt idx="11">
                  <c:v>S-S3_vs_T-S3</c:v>
                </c:pt>
                <c:pt idx="12">
                  <c:v>P-S2_vs_T-S2</c:v>
                </c:pt>
                <c:pt idx="13">
                  <c:v>P-S3_vs_T-S3</c:v>
                </c:pt>
                <c:pt idx="14">
                  <c:v>P-S1_vs_T-S1</c:v>
                </c:pt>
                <c:pt idx="15">
                  <c:v>S-S1_vs_P-S1</c:v>
                </c:pt>
                <c:pt idx="16">
                  <c:v>S-S3_vs_P-S3</c:v>
                </c:pt>
                <c:pt idx="17">
                  <c:v>S-S2_vs_P-S2</c:v>
                </c:pt>
              </c:strCache>
            </c:strRef>
          </c:cat>
          <c:val>
            <c:numRef>
              <c:f>Sheet1!$D$3:$D$20</c:f>
              <c:numCache>
                <c:formatCode>General</c:formatCode>
                <c:ptCount val="18"/>
                <c:pt idx="0">
                  <c:v>602</c:v>
                </c:pt>
                <c:pt idx="1">
                  <c:v>690</c:v>
                </c:pt>
                <c:pt idx="2">
                  <c:v>1097</c:v>
                </c:pt>
                <c:pt idx="3">
                  <c:v>1348</c:v>
                </c:pt>
                <c:pt idx="4">
                  <c:v>2237</c:v>
                </c:pt>
                <c:pt idx="5">
                  <c:v>2292</c:v>
                </c:pt>
                <c:pt idx="6">
                  <c:v>3886</c:v>
                </c:pt>
                <c:pt idx="7">
                  <c:v>4030</c:v>
                </c:pt>
                <c:pt idx="8">
                  <c:v>6593</c:v>
                </c:pt>
                <c:pt idx="9">
                  <c:v>7342</c:v>
                </c:pt>
                <c:pt idx="10">
                  <c:v>8816</c:v>
                </c:pt>
                <c:pt idx="11">
                  <c:v>8923</c:v>
                </c:pt>
                <c:pt idx="12">
                  <c:v>11106</c:v>
                </c:pt>
                <c:pt idx="13">
                  <c:v>11636</c:v>
                </c:pt>
                <c:pt idx="14">
                  <c:v>12276</c:v>
                </c:pt>
                <c:pt idx="15">
                  <c:v>17508</c:v>
                </c:pt>
                <c:pt idx="16">
                  <c:v>18039</c:v>
                </c:pt>
                <c:pt idx="17">
                  <c:v>193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2DC-41FB-97A6-E5466C5DE0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947703487"/>
        <c:axId val="1947711167"/>
      </c:barChart>
      <c:catAx>
        <c:axId val="194770348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  <a:headEnd type="none" w="sm" len="sm"/>
            <a:tailEnd type="none" w="sm" len="sm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947711167"/>
        <c:crosses val="autoZero"/>
        <c:auto val="1"/>
        <c:lblAlgn val="ctr"/>
        <c:lblOffset val="100"/>
        <c:noMultiLvlLbl val="0"/>
      </c:catAx>
      <c:valAx>
        <c:axId val="1947711167"/>
        <c:scaling>
          <c:orientation val="minMax"/>
        </c:scaling>
        <c:delete val="0"/>
        <c:axPos val="b"/>
        <c:majorGridlines>
          <c:spPr>
            <a:ln w="9525" cap="flat" cmpd="sng" algn="ctr">
              <a:gradFill>
                <a:gsLst>
                  <a:gs pos="0">
                    <a:schemeClr val="tx1">
                      <a:lumMod val="5000"/>
                      <a:lumOff val="95000"/>
                    </a:schemeClr>
                  </a:gs>
                  <a:gs pos="100000">
                    <a:schemeClr val="tx1">
                      <a:lumMod val="15000"/>
                      <a:lumOff val="85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94770348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8275226508422628"/>
          <c:y val="0.54752522601341491"/>
          <c:w val="0.38814807460415651"/>
          <c:h val="5.310396298675040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  <a:headEnd type="none" w="sm" len="sm"/>
        <a:tailEnd type="none" w="sm" len="sm"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46000">
            <a:schemeClr val="phClr"/>
          </a:gs>
          <a:gs pos="100000">
            <a:schemeClr val="phClr">
              <a:lumMod val="20000"/>
              <a:lumOff val="80000"/>
              <a:alpha val="0"/>
            </a:schemeClr>
          </a:gs>
        </a:gsLst>
        <a:path path="circle">
          <a:fillToRect l="50000" t="-80000" r="50000" b="180000"/>
        </a:path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CB12D4-EE8D-4D40-81A4-2E532AC0D619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41438" y="1143000"/>
            <a:ext cx="4175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882C7E-84FB-4544-8DB6-BD18F61D0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120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41438" y="1143000"/>
            <a:ext cx="41751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882C7E-84FB-4544-8DB6-BD18F61D0EF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94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31620" y="2469199"/>
            <a:ext cx="17358360" cy="5252720"/>
          </a:xfrm>
        </p:spPr>
        <p:txBody>
          <a:bodyPr anchor="b"/>
          <a:lstStyle>
            <a:lvl1pPr algn="ctr">
              <a:defRPr sz="1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552700" y="7924484"/>
            <a:ext cx="15316200" cy="3642676"/>
          </a:xfrm>
        </p:spPr>
        <p:txBody>
          <a:bodyPr/>
          <a:lstStyle>
            <a:lvl1pPr marL="0" indent="0" algn="ctr">
              <a:buNone/>
              <a:defRPr sz="5280"/>
            </a:lvl1pPr>
            <a:lvl2pPr marL="1005840" indent="0" algn="ctr">
              <a:buNone/>
              <a:defRPr sz="4400"/>
            </a:lvl2pPr>
            <a:lvl3pPr marL="2011680" indent="0" algn="ctr">
              <a:buNone/>
              <a:defRPr sz="3960"/>
            </a:lvl3pPr>
            <a:lvl4pPr marL="3017520" indent="0" algn="ctr">
              <a:buNone/>
              <a:defRPr sz="3520"/>
            </a:lvl4pPr>
            <a:lvl5pPr marL="4023360" indent="0" algn="ctr">
              <a:buNone/>
              <a:defRPr sz="3520"/>
            </a:lvl5pPr>
            <a:lvl6pPr marL="5029200" indent="0" algn="ctr">
              <a:buNone/>
              <a:defRPr sz="3520"/>
            </a:lvl6pPr>
            <a:lvl7pPr marL="6035040" indent="0" algn="ctr">
              <a:buNone/>
              <a:defRPr sz="3520"/>
            </a:lvl7pPr>
            <a:lvl8pPr marL="7040880" indent="0" algn="ctr">
              <a:buNone/>
              <a:defRPr sz="3520"/>
            </a:lvl8pPr>
            <a:lvl9pPr marL="8046720" indent="0" algn="ctr">
              <a:buNone/>
              <a:defRPr sz="3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794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30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614208" y="803275"/>
            <a:ext cx="4403408" cy="127860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03986" y="803275"/>
            <a:ext cx="12954953" cy="127860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385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63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93350" y="3761427"/>
            <a:ext cx="17613630" cy="6276021"/>
          </a:xfrm>
        </p:spPr>
        <p:txBody>
          <a:bodyPr anchor="b"/>
          <a:lstStyle>
            <a:lvl1pPr>
              <a:defRPr sz="1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93350" y="10096822"/>
            <a:ext cx="17613630" cy="3300411"/>
          </a:xfrm>
        </p:spPr>
        <p:txBody>
          <a:bodyPr/>
          <a:lstStyle>
            <a:lvl1pPr marL="0" indent="0">
              <a:buNone/>
              <a:defRPr sz="5280">
                <a:solidFill>
                  <a:schemeClr val="tx1">
                    <a:tint val="82000"/>
                  </a:schemeClr>
                </a:solidFill>
              </a:defRPr>
            </a:lvl1pPr>
            <a:lvl2pPr marL="1005840" indent="0">
              <a:buNone/>
              <a:defRPr sz="4400">
                <a:solidFill>
                  <a:schemeClr val="tx1">
                    <a:tint val="82000"/>
                  </a:schemeClr>
                </a:solidFill>
              </a:defRPr>
            </a:lvl2pPr>
            <a:lvl3pPr marL="2011680" indent="0">
              <a:buNone/>
              <a:defRPr sz="3960">
                <a:solidFill>
                  <a:schemeClr val="tx1">
                    <a:tint val="82000"/>
                  </a:schemeClr>
                </a:solidFill>
              </a:defRPr>
            </a:lvl3pPr>
            <a:lvl4pPr marL="301752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4pPr>
            <a:lvl5pPr marL="402336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5pPr>
            <a:lvl6pPr marL="502920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6pPr>
            <a:lvl7pPr marL="603504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7pPr>
            <a:lvl8pPr marL="704088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8pPr>
            <a:lvl9pPr marL="8046720" indent="0">
              <a:buNone/>
              <a:defRPr sz="35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3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03985" y="4016375"/>
            <a:ext cx="8679180" cy="95729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338435" y="4016375"/>
            <a:ext cx="8679180" cy="95729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434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6645" y="803278"/>
            <a:ext cx="17613630" cy="291623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06647" y="3698559"/>
            <a:ext cx="8639293" cy="1812606"/>
          </a:xfrm>
        </p:spPr>
        <p:txBody>
          <a:bodyPr anchor="b"/>
          <a:lstStyle>
            <a:lvl1pPr marL="0" indent="0">
              <a:buNone/>
              <a:defRPr sz="5280" b="1"/>
            </a:lvl1pPr>
            <a:lvl2pPr marL="1005840" indent="0">
              <a:buNone/>
              <a:defRPr sz="4400" b="1"/>
            </a:lvl2pPr>
            <a:lvl3pPr marL="2011680" indent="0">
              <a:buNone/>
              <a:defRPr sz="3960" b="1"/>
            </a:lvl3pPr>
            <a:lvl4pPr marL="3017520" indent="0">
              <a:buNone/>
              <a:defRPr sz="3520" b="1"/>
            </a:lvl4pPr>
            <a:lvl5pPr marL="4023360" indent="0">
              <a:buNone/>
              <a:defRPr sz="3520" b="1"/>
            </a:lvl5pPr>
            <a:lvl6pPr marL="5029200" indent="0">
              <a:buNone/>
              <a:defRPr sz="3520" b="1"/>
            </a:lvl6pPr>
            <a:lvl7pPr marL="6035040" indent="0">
              <a:buNone/>
              <a:defRPr sz="3520" b="1"/>
            </a:lvl7pPr>
            <a:lvl8pPr marL="7040880" indent="0">
              <a:buNone/>
              <a:defRPr sz="3520" b="1"/>
            </a:lvl8pPr>
            <a:lvl9pPr marL="8046720" indent="0">
              <a:buNone/>
              <a:defRPr sz="3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06647" y="5511165"/>
            <a:ext cx="8639293" cy="81060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338436" y="3698559"/>
            <a:ext cx="8681840" cy="1812606"/>
          </a:xfrm>
        </p:spPr>
        <p:txBody>
          <a:bodyPr anchor="b"/>
          <a:lstStyle>
            <a:lvl1pPr marL="0" indent="0">
              <a:buNone/>
              <a:defRPr sz="5280" b="1"/>
            </a:lvl1pPr>
            <a:lvl2pPr marL="1005840" indent="0">
              <a:buNone/>
              <a:defRPr sz="4400" b="1"/>
            </a:lvl2pPr>
            <a:lvl3pPr marL="2011680" indent="0">
              <a:buNone/>
              <a:defRPr sz="3960" b="1"/>
            </a:lvl3pPr>
            <a:lvl4pPr marL="3017520" indent="0">
              <a:buNone/>
              <a:defRPr sz="3520" b="1"/>
            </a:lvl4pPr>
            <a:lvl5pPr marL="4023360" indent="0">
              <a:buNone/>
              <a:defRPr sz="3520" b="1"/>
            </a:lvl5pPr>
            <a:lvl6pPr marL="5029200" indent="0">
              <a:buNone/>
              <a:defRPr sz="3520" b="1"/>
            </a:lvl6pPr>
            <a:lvl7pPr marL="6035040" indent="0">
              <a:buNone/>
              <a:defRPr sz="3520" b="1"/>
            </a:lvl7pPr>
            <a:lvl8pPr marL="7040880" indent="0">
              <a:buNone/>
              <a:defRPr sz="3520" b="1"/>
            </a:lvl8pPr>
            <a:lvl9pPr marL="8046720" indent="0">
              <a:buNone/>
              <a:defRPr sz="3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338436" y="5511165"/>
            <a:ext cx="8681840" cy="81060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278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66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71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6645" y="1005840"/>
            <a:ext cx="6586498" cy="3520440"/>
          </a:xfrm>
        </p:spPr>
        <p:txBody>
          <a:bodyPr anchor="b"/>
          <a:lstStyle>
            <a:lvl1pPr>
              <a:defRPr sz="7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681840" y="2172338"/>
            <a:ext cx="10338435" cy="10721975"/>
          </a:xfrm>
        </p:spPr>
        <p:txBody>
          <a:bodyPr/>
          <a:lstStyle>
            <a:lvl1pPr>
              <a:defRPr sz="7040"/>
            </a:lvl1pPr>
            <a:lvl2pPr>
              <a:defRPr sz="6160"/>
            </a:lvl2pPr>
            <a:lvl3pPr>
              <a:defRPr sz="5280"/>
            </a:lvl3pPr>
            <a:lvl4pPr>
              <a:defRPr sz="4400"/>
            </a:lvl4pPr>
            <a:lvl5pPr>
              <a:defRPr sz="4400"/>
            </a:lvl5pPr>
            <a:lvl6pPr>
              <a:defRPr sz="4400"/>
            </a:lvl6pPr>
            <a:lvl7pPr>
              <a:defRPr sz="4400"/>
            </a:lvl7pPr>
            <a:lvl8pPr>
              <a:defRPr sz="4400"/>
            </a:lvl8pPr>
            <a:lvl9pPr>
              <a:defRPr sz="4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6645" y="4526280"/>
            <a:ext cx="6586498" cy="8385494"/>
          </a:xfrm>
        </p:spPr>
        <p:txBody>
          <a:bodyPr/>
          <a:lstStyle>
            <a:lvl1pPr marL="0" indent="0">
              <a:buNone/>
              <a:defRPr sz="3520"/>
            </a:lvl1pPr>
            <a:lvl2pPr marL="1005840" indent="0">
              <a:buNone/>
              <a:defRPr sz="3080"/>
            </a:lvl2pPr>
            <a:lvl3pPr marL="2011680" indent="0">
              <a:buNone/>
              <a:defRPr sz="2640"/>
            </a:lvl3pPr>
            <a:lvl4pPr marL="3017520" indent="0">
              <a:buNone/>
              <a:defRPr sz="2200"/>
            </a:lvl4pPr>
            <a:lvl5pPr marL="4023360" indent="0">
              <a:buNone/>
              <a:defRPr sz="2200"/>
            </a:lvl5pPr>
            <a:lvl6pPr marL="5029200" indent="0">
              <a:buNone/>
              <a:defRPr sz="2200"/>
            </a:lvl6pPr>
            <a:lvl7pPr marL="6035040" indent="0">
              <a:buNone/>
              <a:defRPr sz="2200"/>
            </a:lvl7pPr>
            <a:lvl8pPr marL="7040880" indent="0">
              <a:buNone/>
              <a:defRPr sz="2200"/>
            </a:lvl8pPr>
            <a:lvl9pPr marL="8046720" indent="0">
              <a:buNone/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591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6645" y="1005840"/>
            <a:ext cx="6586498" cy="3520440"/>
          </a:xfrm>
        </p:spPr>
        <p:txBody>
          <a:bodyPr anchor="b"/>
          <a:lstStyle>
            <a:lvl1pPr>
              <a:defRPr sz="7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681840" y="2172338"/>
            <a:ext cx="10338435" cy="10721975"/>
          </a:xfrm>
        </p:spPr>
        <p:txBody>
          <a:bodyPr anchor="t"/>
          <a:lstStyle>
            <a:lvl1pPr marL="0" indent="0">
              <a:buNone/>
              <a:defRPr sz="7040"/>
            </a:lvl1pPr>
            <a:lvl2pPr marL="1005840" indent="0">
              <a:buNone/>
              <a:defRPr sz="6160"/>
            </a:lvl2pPr>
            <a:lvl3pPr marL="2011680" indent="0">
              <a:buNone/>
              <a:defRPr sz="5280"/>
            </a:lvl3pPr>
            <a:lvl4pPr marL="3017520" indent="0">
              <a:buNone/>
              <a:defRPr sz="4400"/>
            </a:lvl4pPr>
            <a:lvl5pPr marL="4023360" indent="0">
              <a:buNone/>
              <a:defRPr sz="4400"/>
            </a:lvl5pPr>
            <a:lvl6pPr marL="5029200" indent="0">
              <a:buNone/>
              <a:defRPr sz="4400"/>
            </a:lvl6pPr>
            <a:lvl7pPr marL="6035040" indent="0">
              <a:buNone/>
              <a:defRPr sz="4400"/>
            </a:lvl7pPr>
            <a:lvl8pPr marL="7040880" indent="0">
              <a:buNone/>
              <a:defRPr sz="4400"/>
            </a:lvl8pPr>
            <a:lvl9pPr marL="8046720" indent="0">
              <a:buNone/>
              <a:defRPr sz="4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6645" y="4526280"/>
            <a:ext cx="6586498" cy="8385494"/>
          </a:xfrm>
        </p:spPr>
        <p:txBody>
          <a:bodyPr/>
          <a:lstStyle>
            <a:lvl1pPr marL="0" indent="0">
              <a:buNone/>
              <a:defRPr sz="3520"/>
            </a:lvl1pPr>
            <a:lvl2pPr marL="1005840" indent="0">
              <a:buNone/>
              <a:defRPr sz="3080"/>
            </a:lvl2pPr>
            <a:lvl3pPr marL="2011680" indent="0">
              <a:buNone/>
              <a:defRPr sz="2640"/>
            </a:lvl3pPr>
            <a:lvl4pPr marL="3017520" indent="0">
              <a:buNone/>
              <a:defRPr sz="2200"/>
            </a:lvl4pPr>
            <a:lvl5pPr marL="4023360" indent="0">
              <a:buNone/>
              <a:defRPr sz="2200"/>
            </a:lvl5pPr>
            <a:lvl6pPr marL="5029200" indent="0">
              <a:buNone/>
              <a:defRPr sz="2200"/>
            </a:lvl6pPr>
            <a:lvl7pPr marL="6035040" indent="0">
              <a:buNone/>
              <a:defRPr sz="2200"/>
            </a:lvl7pPr>
            <a:lvl8pPr marL="7040880" indent="0">
              <a:buNone/>
              <a:defRPr sz="2200"/>
            </a:lvl8pPr>
            <a:lvl9pPr marL="8046720" indent="0">
              <a:buNone/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584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03985" y="803278"/>
            <a:ext cx="17613630" cy="291623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03985" y="4016375"/>
            <a:ext cx="17613630" cy="95729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03985" y="13983973"/>
            <a:ext cx="4594860" cy="803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6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369E9D-79BA-4F24-82B2-FC205741B4DF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764655" y="13983973"/>
            <a:ext cx="6892290" cy="803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6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422755" y="13983973"/>
            <a:ext cx="4594860" cy="803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6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5D15D2-268E-4D35-8599-4A5FC696C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199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011680" rtl="0" eaLnBrk="1" latinLnBrk="0" hangingPunct="1">
        <a:lnSpc>
          <a:spcPct val="90000"/>
        </a:lnSpc>
        <a:spcBef>
          <a:spcPct val="0"/>
        </a:spcBef>
        <a:buNone/>
        <a:defRPr sz="96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2920" indent="-502920" algn="l" defTabSz="2011680" rtl="0" eaLnBrk="1" latinLnBrk="0" hangingPunct="1">
        <a:lnSpc>
          <a:spcPct val="90000"/>
        </a:lnSpc>
        <a:spcBef>
          <a:spcPts val="2200"/>
        </a:spcBef>
        <a:buFont typeface="Arial" panose="020B0604020202020204" pitchFamily="34" charset="0"/>
        <a:buChar char="•"/>
        <a:defRPr sz="6160" kern="1200">
          <a:solidFill>
            <a:schemeClr val="tx1"/>
          </a:solidFill>
          <a:latin typeface="+mn-lt"/>
          <a:ea typeface="+mn-ea"/>
          <a:cs typeface="+mn-cs"/>
        </a:defRPr>
      </a:lvl1pPr>
      <a:lvl2pPr marL="150876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2pPr>
      <a:lvl3pPr marL="251460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4400" kern="1200">
          <a:solidFill>
            <a:schemeClr val="tx1"/>
          </a:solidFill>
          <a:latin typeface="+mn-lt"/>
          <a:ea typeface="+mn-ea"/>
          <a:cs typeface="+mn-cs"/>
        </a:defRPr>
      </a:lvl3pPr>
      <a:lvl4pPr marL="352044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4pPr>
      <a:lvl5pPr marL="452628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5pPr>
      <a:lvl6pPr marL="553212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6pPr>
      <a:lvl7pPr marL="653796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7pPr>
      <a:lvl8pPr marL="754380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8pPr>
      <a:lvl9pPr marL="8549640" indent="-502920" algn="l" defTabSz="201168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1pPr>
      <a:lvl2pPr marL="100584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2pPr>
      <a:lvl3pPr marL="201168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3pPr>
      <a:lvl4pPr marL="301752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4pPr>
      <a:lvl5pPr marL="402336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6pPr>
      <a:lvl7pPr marL="603504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7pPr>
      <a:lvl8pPr marL="704088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8pPr>
      <a:lvl9pPr marL="8046720" algn="l" defTabSz="2011680" rtl="0" eaLnBrk="1" latinLnBrk="0" hangingPunct="1">
        <a:defRPr sz="3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C0D04A7-E8DA-3C5E-D694-78BDA9D6B1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8226604"/>
              </p:ext>
            </p:extLst>
          </p:nvPr>
        </p:nvGraphicFramePr>
        <p:xfrm>
          <a:off x="711200" y="609600"/>
          <a:ext cx="18525067" cy="13309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165159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1</Words>
  <Application>Microsoft Office PowerPoint</Application>
  <PresentationFormat>Custom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Government College University Faisalab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A</dc:creator>
  <cp:lastModifiedBy>Authors</cp:lastModifiedBy>
  <cp:revision>15</cp:revision>
  <dcterms:created xsi:type="dcterms:W3CDTF">2025-11-02T18:20:57Z</dcterms:created>
  <dcterms:modified xsi:type="dcterms:W3CDTF">2025-11-21T05:07:03Z</dcterms:modified>
</cp:coreProperties>
</file>